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12192000" cy="118872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52A2A"/>
    <a:srgbClr val="800080"/>
    <a:srgbClr val="FFFFFF"/>
    <a:srgbClr val="FF0000"/>
    <a:srgbClr val="008000"/>
    <a:srgbClr val="FFA500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144F838-9044-43F7-9360-214EA772025C}" v="18" dt="2025-01-31T00:09:18.78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60"/>
  </p:normalViewPr>
  <p:slideViewPr>
    <p:cSldViewPr snapToGrid="0">
      <p:cViewPr>
        <p:scale>
          <a:sx n="100" d="100"/>
          <a:sy n="100" d="100"/>
        </p:scale>
        <p:origin x="14" y="-354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effery Adam Goldstein" userId="0b3b19fa-dd4d-4aa8-9e21-ef13bf5103f5" providerId="ADAL" clId="{F144F838-9044-43F7-9360-214EA772025C}"/>
    <pc:docChg chg="custSel modSld">
      <pc:chgData name="Jeffery Adam Goldstein" userId="0b3b19fa-dd4d-4aa8-9e21-ef13bf5103f5" providerId="ADAL" clId="{F144F838-9044-43F7-9360-214EA772025C}" dt="2025-01-31T00:09:18.788" v="143" actId="164"/>
      <pc:docMkLst>
        <pc:docMk/>
      </pc:docMkLst>
      <pc:sldChg chg="addSp delSp modSp mod">
        <pc:chgData name="Jeffery Adam Goldstein" userId="0b3b19fa-dd4d-4aa8-9e21-ef13bf5103f5" providerId="ADAL" clId="{F144F838-9044-43F7-9360-214EA772025C}" dt="2025-01-31T00:09:18.788" v="143" actId="164"/>
        <pc:sldMkLst>
          <pc:docMk/>
          <pc:sldMk cId="3329587969" sldId="256"/>
        </pc:sldMkLst>
        <pc:spChg chg="add mod topLvl">
          <ac:chgData name="Jeffery Adam Goldstein" userId="0b3b19fa-dd4d-4aa8-9e21-ef13bf5103f5" providerId="ADAL" clId="{F144F838-9044-43F7-9360-214EA772025C}" dt="2025-01-31T00:07:55.459" v="123" actId="164"/>
          <ac:spMkLst>
            <pc:docMk/>
            <pc:sldMk cId="3329587969" sldId="256"/>
            <ac:spMk id="4" creationId="{B0B253E8-AA81-7784-4CF4-BD1BCFB24810}"/>
          </ac:spMkLst>
        </pc:spChg>
        <pc:spChg chg="add mod topLvl">
          <ac:chgData name="Jeffery Adam Goldstein" userId="0b3b19fa-dd4d-4aa8-9e21-ef13bf5103f5" providerId="ADAL" clId="{F144F838-9044-43F7-9360-214EA772025C}" dt="2025-01-31T00:08:50.020" v="136" actId="14100"/>
          <ac:spMkLst>
            <pc:docMk/>
            <pc:sldMk cId="3329587969" sldId="256"/>
            <ac:spMk id="6" creationId="{B09B9FCC-A94F-3F87-8E20-AFBC0DF3C14A}"/>
          </ac:spMkLst>
        </pc:spChg>
        <pc:spChg chg="add mod topLvl">
          <ac:chgData name="Jeffery Adam Goldstein" userId="0b3b19fa-dd4d-4aa8-9e21-ef13bf5103f5" providerId="ADAL" clId="{F144F838-9044-43F7-9360-214EA772025C}" dt="2025-01-31T00:07:56.926" v="124" actId="164"/>
          <ac:spMkLst>
            <pc:docMk/>
            <pc:sldMk cId="3329587969" sldId="256"/>
            <ac:spMk id="7" creationId="{B000EBE4-CD29-855E-EA96-660F9A0EDBA6}"/>
          </ac:spMkLst>
        </pc:spChg>
        <pc:spChg chg="add mod topLvl">
          <ac:chgData name="Jeffery Adam Goldstein" userId="0b3b19fa-dd4d-4aa8-9e21-ef13bf5103f5" providerId="ADAL" clId="{F144F838-9044-43F7-9360-214EA772025C}" dt="2025-01-31T00:08:47.841" v="135" actId="14100"/>
          <ac:spMkLst>
            <pc:docMk/>
            <pc:sldMk cId="3329587969" sldId="256"/>
            <ac:spMk id="8" creationId="{C0737803-860C-7FCA-FFD5-94D8C9728C79}"/>
          </ac:spMkLst>
        </pc:spChg>
        <pc:spChg chg="add mod">
          <ac:chgData name="Jeffery Adam Goldstein" userId="0b3b19fa-dd4d-4aa8-9e21-ef13bf5103f5" providerId="ADAL" clId="{F144F838-9044-43F7-9360-214EA772025C}" dt="2025-01-31T00:06:50.871" v="86" actId="164"/>
          <ac:spMkLst>
            <pc:docMk/>
            <pc:sldMk cId="3329587969" sldId="256"/>
            <ac:spMk id="10" creationId="{AF788E49-DDA2-C715-BD4F-449B1C7FD50B}"/>
          </ac:spMkLst>
        </pc:spChg>
        <pc:spChg chg="add mod">
          <ac:chgData name="Jeffery Adam Goldstein" userId="0b3b19fa-dd4d-4aa8-9e21-ef13bf5103f5" providerId="ADAL" clId="{F144F838-9044-43F7-9360-214EA772025C}" dt="2025-01-31T00:08:43.617" v="133" actId="14100"/>
          <ac:spMkLst>
            <pc:docMk/>
            <pc:sldMk cId="3329587969" sldId="256"/>
            <ac:spMk id="12" creationId="{858EE895-3493-A0D7-5D2A-36A3AF002D58}"/>
          </ac:spMkLst>
        </pc:spChg>
        <pc:spChg chg="add mod">
          <ac:chgData name="Jeffery Adam Goldstein" userId="0b3b19fa-dd4d-4aa8-9e21-ef13bf5103f5" providerId="ADAL" clId="{F144F838-9044-43F7-9360-214EA772025C}" dt="2025-01-31T00:07:21.327" v="109" actId="164"/>
          <ac:spMkLst>
            <pc:docMk/>
            <pc:sldMk cId="3329587969" sldId="256"/>
            <ac:spMk id="20" creationId="{FAC5613B-9187-B2F7-E224-EF382B47A36E}"/>
          </ac:spMkLst>
        </pc:spChg>
        <pc:spChg chg="add mod">
          <ac:chgData name="Jeffery Adam Goldstein" userId="0b3b19fa-dd4d-4aa8-9e21-ef13bf5103f5" providerId="ADAL" clId="{F144F838-9044-43F7-9360-214EA772025C}" dt="2025-01-31T00:08:52.287" v="137" actId="14100"/>
          <ac:spMkLst>
            <pc:docMk/>
            <pc:sldMk cId="3329587969" sldId="256"/>
            <ac:spMk id="21" creationId="{DC990B61-FB58-A35E-97FB-D00A803E6814}"/>
          </ac:spMkLst>
        </pc:spChg>
        <pc:spChg chg="add mod">
          <ac:chgData name="Jeffery Adam Goldstein" userId="0b3b19fa-dd4d-4aa8-9e21-ef13bf5103f5" providerId="ADAL" clId="{F144F838-9044-43F7-9360-214EA772025C}" dt="2025-01-31T00:07:02.757" v="96" actId="164"/>
          <ac:spMkLst>
            <pc:docMk/>
            <pc:sldMk cId="3329587969" sldId="256"/>
            <ac:spMk id="22" creationId="{95B60C69-BE69-81E8-48C3-F6C1B413ADB1}"/>
          </ac:spMkLst>
        </pc:spChg>
        <pc:spChg chg="add mod">
          <ac:chgData name="Jeffery Adam Goldstein" userId="0b3b19fa-dd4d-4aa8-9e21-ef13bf5103f5" providerId="ADAL" clId="{F144F838-9044-43F7-9360-214EA772025C}" dt="2025-01-31T00:08:45.709" v="134" actId="14100"/>
          <ac:spMkLst>
            <pc:docMk/>
            <pc:sldMk cId="3329587969" sldId="256"/>
            <ac:spMk id="24" creationId="{3F4D3524-CD4A-C782-681D-CACCEC4E820D}"/>
          </ac:spMkLst>
        </pc:spChg>
        <pc:spChg chg="add mod">
          <ac:chgData name="Jeffery Adam Goldstein" userId="0b3b19fa-dd4d-4aa8-9e21-ef13bf5103f5" providerId="ADAL" clId="{F144F838-9044-43F7-9360-214EA772025C}" dt="2025-01-31T00:07:39.487" v="120" actId="164"/>
          <ac:spMkLst>
            <pc:docMk/>
            <pc:sldMk cId="3329587969" sldId="256"/>
            <ac:spMk id="26" creationId="{14CB296C-677C-CB08-2E85-C7DA551FACBB}"/>
          </ac:spMkLst>
        </pc:spChg>
        <pc:spChg chg="add mod">
          <ac:chgData name="Jeffery Adam Goldstein" userId="0b3b19fa-dd4d-4aa8-9e21-ef13bf5103f5" providerId="ADAL" clId="{F144F838-9044-43F7-9360-214EA772025C}" dt="2025-01-31T00:08:54.671" v="138" actId="14100"/>
          <ac:spMkLst>
            <pc:docMk/>
            <pc:sldMk cId="3329587969" sldId="256"/>
            <ac:spMk id="28" creationId="{9A67CDF9-EC78-64BB-921B-39D3F2D1B3CE}"/>
          </ac:spMkLst>
        </pc:spChg>
        <pc:grpChg chg="add del mod">
          <ac:chgData name="Jeffery Adam Goldstein" userId="0b3b19fa-dd4d-4aa8-9e21-ef13bf5103f5" providerId="ADAL" clId="{F144F838-9044-43F7-9360-214EA772025C}" dt="2025-01-31T00:06:04.754" v="64" actId="165"/>
          <ac:grpSpMkLst>
            <pc:docMk/>
            <pc:sldMk cId="3329587969" sldId="256"/>
            <ac:grpSpMk id="34" creationId="{F5859591-84C8-B864-6447-D9D1FBA68EA4}"/>
          </ac:grpSpMkLst>
        </pc:grpChg>
        <pc:grpChg chg="add del mod">
          <ac:chgData name="Jeffery Adam Goldstein" userId="0b3b19fa-dd4d-4aa8-9e21-ef13bf5103f5" providerId="ADAL" clId="{F144F838-9044-43F7-9360-214EA772025C}" dt="2025-01-31T00:06:04.754" v="64" actId="165"/>
          <ac:grpSpMkLst>
            <pc:docMk/>
            <pc:sldMk cId="3329587969" sldId="256"/>
            <ac:grpSpMk id="35" creationId="{C4283B72-8D12-A387-811E-3B5E361CCBD4}"/>
          </ac:grpSpMkLst>
        </pc:grpChg>
        <pc:grpChg chg="add mod">
          <ac:chgData name="Jeffery Adam Goldstein" userId="0b3b19fa-dd4d-4aa8-9e21-ef13bf5103f5" providerId="ADAL" clId="{F144F838-9044-43F7-9360-214EA772025C}" dt="2025-01-31T00:09:18.788" v="143" actId="164"/>
          <ac:grpSpMkLst>
            <pc:docMk/>
            <pc:sldMk cId="3329587969" sldId="256"/>
            <ac:grpSpMk id="36" creationId="{252A73A2-FF27-5B3B-8DB4-DBF1FCE9D9B7}"/>
          </ac:grpSpMkLst>
        </pc:grpChg>
        <pc:grpChg chg="add mod">
          <ac:chgData name="Jeffery Adam Goldstein" userId="0b3b19fa-dd4d-4aa8-9e21-ef13bf5103f5" providerId="ADAL" clId="{F144F838-9044-43F7-9360-214EA772025C}" dt="2025-01-31T00:09:18.788" v="143" actId="164"/>
          <ac:grpSpMkLst>
            <pc:docMk/>
            <pc:sldMk cId="3329587969" sldId="256"/>
            <ac:grpSpMk id="37" creationId="{C3874925-C012-77C2-8DED-E953D34E4DF5}"/>
          </ac:grpSpMkLst>
        </pc:grpChg>
        <pc:grpChg chg="add mod">
          <ac:chgData name="Jeffery Adam Goldstein" userId="0b3b19fa-dd4d-4aa8-9e21-ef13bf5103f5" providerId="ADAL" clId="{F144F838-9044-43F7-9360-214EA772025C}" dt="2025-01-31T00:09:18.788" v="143" actId="164"/>
          <ac:grpSpMkLst>
            <pc:docMk/>
            <pc:sldMk cId="3329587969" sldId="256"/>
            <ac:grpSpMk id="38" creationId="{A899B279-E5A0-F324-2123-410E0CB9CF62}"/>
          </ac:grpSpMkLst>
        </pc:grpChg>
        <pc:grpChg chg="add mod">
          <ac:chgData name="Jeffery Adam Goldstein" userId="0b3b19fa-dd4d-4aa8-9e21-ef13bf5103f5" providerId="ADAL" clId="{F144F838-9044-43F7-9360-214EA772025C}" dt="2025-01-31T00:09:18.788" v="143" actId="164"/>
          <ac:grpSpMkLst>
            <pc:docMk/>
            <pc:sldMk cId="3329587969" sldId="256"/>
            <ac:grpSpMk id="39" creationId="{E160E0A0-03B7-6D8C-29C2-1AC4B1264A43}"/>
          </ac:grpSpMkLst>
        </pc:grpChg>
        <pc:grpChg chg="add mod">
          <ac:chgData name="Jeffery Adam Goldstein" userId="0b3b19fa-dd4d-4aa8-9e21-ef13bf5103f5" providerId="ADAL" clId="{F144F838-9044-43F7-9360-214EA772025C}" dt="2025-01-31T00:09:18.788" v="143" actId="164"/>
          <ac:grpSpMkLst>
            <pc:docMk/>
            <pc:sldMk cId="3329587969" sldId="256"/>
            <ac:grpSpMk id="40" creationId="{992ED330-4312-6EE9-BEE9-49337D9DFB72}"/>
          </ac:grpSpMkLst>
        </pc:grpChg>
        <pc:grpChg chg="add mod">
          <ac:chgData name="Jeffery Adam Goldstein" userId="0b3b19fa-dd4d-4aa8-9e21-ef13bf5103f5" providerId="ADAL" clId="{F144F838-9044-43F7-9360-214EA772025C}" dt="2025-01-31T00:09:18.788" v="143" actId="164"/>
          <ac:grpSpMkLst>
            <pc:docMk/>
            <pc:sldMk cId="3329587969" sldId="256"/>
            <ac:grpSpMk id="41" creationId="{1A59A6F7-27CB-8604-E739-4B84FA98A6B3}"/>
          </ac:grpSpMkLst>
        </pc:grpChg>
        <pc:grpChg chg="add mod">
          <ac:chgData name="Jeffery Adam Goldstein" userId="0b3b19fa-dd4d-4aa8-9e21-ef13bf5103f5" providerId="ADAL" clId="{F144F838-9044-43F7-9360-214EA772025C}" dt="2025-01-31T00:09:18.788" v="143" actId="164"/>
          <ac:grpSpMkLst>
            <pc:docMk/>
            <pc:sldMk cId="3329587969" sldId="256"/>
            <ac:grpSpMk id="42" creationId="{23C312F5-E6F0-FDFF-18EE-6109E6FAB48A}"/>
          </ac:grpSpMkLst>
        </pc:grpChg>
        <pc:graphicFrameChg chg="add del mod modGraphic">
          <ac:chgData name="Jeffery Adam Goldstein" userId="0b3b19fa-dd4d-4aa8-9e21-ef13bf5103f5" providerId="ADAL" clId="{F144F838-9044-43F7-9360-214EA772025C}" dt="2025-01-31T00:02:00.909" v="3" actId="478"/>
          <ac:graphicFrameMkLst>
            <pc:docMk/>
            <pc:sldMk cId="3329587969" sldId="256"/>
            <ac:graphicFrameMk id="34" creationId="{03824A4A-FB75-67D3-1335-E883FDE26985}"/>
          </ac:graphicFrameMkLst>
        </pc:graphicFrameChg>
        <pc:picChg chg="add del mod modCrop">
          <ac:chgData name="Jeffery Adam Goldstein" userId="0b3b19fa-dd4d-4aa8-9e21-ef13bf5103f5" providerId="ADAL" clId="{F144F838-9044-43F7-9360-214EA772025C}" dt="2025-01-31T00:05:00.865" v="44" actId="478"/>
          <ac:picMkLst>
            <pc:docMk/>
            <pc:sldMk cId="3329587969" sldId="256"/>
            <ac:picMk id="3" creationId="{C82D8546-5339-C2EB-FEFF-CE6504C1449B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6F2E931-2C6F-4908-A06B-07FDCFA7887A}" type="datetimeFigureOut">
              <a:rPr lang="en-US" smtClean="0"/>
              <a:t>1/30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846263" y="1143000"/>
            <a:ext cx="31654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68542B1-73D1-4FC5-94F5-707EB4600C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02500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68542B1-73D1-4FC5-94F5-707EB4600CB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2519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945429"/>
            <a:ext cx="10363200" cy="413850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6243533"/>
            <a:ext cx="9144000" cy="2869987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D46390-1553-4345-8BF4-449A06A77731}" type="datetimeFigureOut">
              <a:rPr lang="en-US" smtClean="0"/>
              <a:t>1/3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58637-D2F5-4B93-BDBA-3474570FD8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41405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D46390-1553-4345-8BF4-449A06A77731}" type="datetimeFigureOut">
              <a:rPr lang="en-US" smtClean="0"/>
              <a:t>1/3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58637-D2F5-4B93-BDBA-3474570FD8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92254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632883"/>
            <a:ext cx="2628900" cy="1007385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632883"/>
            <a:ext cx="7734300" cy="1007385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D46390-1553-4345-8BF4-449A06A77731}" type="datetimeFigureOut">
              <a:rPr lang="en-US" smtClean="0"/>
              <a:t>1/3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58637-D2F5-4B93-BDBA-3474570FD8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37185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D46390-1553-4345-8BF4-449A06A77731}" type="datetimeFigureOut">
              <a:rPr lang="en-US" smtClean="0"/>
              <a:t>1/3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58637-D2F5-4B93-BDBA-3474570FD8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67800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963549"/>
            <a:ext cx="10515600" cy="4944744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7955072"/>
            <a:ext cx="10515600" cy="2600324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>
                    <a:tint val="82000"/>
                  </a:schemeClr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82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D46390-1553-4345-8BF4-449A06A77731}" type="datetimeFigureOut">
              <a:rPr lang="en-US" smtClean="0"/>
              <a:t>1/3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58637-D2F5-4B93-BDBA-3474570FD8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41365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3164417"/>
            <a:ext cx="5181600" cy="754231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3164417"/>
            <a:ext cx="5181600" cy="754231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D46390-1553-4345-8BF4-449A06A77731}" type="datetimeFigureOut">
              <a:rPr lang="en-US" smtClean="0"/>
              <a:t>1/30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58637-D2F5-4B93-BDBA-3474570FD8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60167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32886"/>
            <a:ext cx="10515600" cy="229764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914016"/>
            <a:ext cx="5157787" cy="1428114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4342130"/>
            <a:ext cx="5157787" cy="638661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914016"/>
            <a:ext cx="5183188" cy="1428114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4342130"/>
            <a:ext cx="5183188" cy="638661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D46390-1553-4345-8BF4-449A06A77731}" type="datetimeFigureOut">
              <a:rPr lang="en-US" smtClean="0"/>
              <a:t>1/30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58637-D2F5-4B93-BDBA-3474570FD8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58225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D46390-1553-4345-8BF4-449A06A77731}" type="datetimeFigureOut">
              <a:rPr lang="en-US" smtClean="0"/>
              <a:t>1/30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58637-D2F5-4B93-BDBA-3474570FD8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36974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D46390-1553-4345-8BF4-449A06A77731}" type="datetimeFigureOut">
              <a:rPr lang="en-US" smtClean="0"/>
              <a:t>1/30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58637-D2F5-4B93-BDBA-3474570FD8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90563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92480"/>
            <a:ext cx="3932237" cy="277368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711539"/>
            <a:ext cx="6172200" cy="844761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566160"/>
            <a:ext cx="3932237" cy="6606753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D46390-1553-4345-8BF4-449A06A77731}" type="datetimeFigureOut">
              <a:rPr lang="en-US" smtClean="0"/>
              <a:t>1/30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58637-D2F5-4B93-BDBA-3474570FD8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49796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92480"/>
            <a:ext cx="3932237" cy="277368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711539"/>
            <a:ext cx="6172200" cy="8447617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566160"/>
            <a:ext cx="3932237" cy="6606753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D46390-1553-4345-8BF4-449A06A77731}" type="datetimeFigureOut">
              <a:rPr lang="en-US" smtClean="0"/>
              <a:t>1/30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58637-D2F5-4B93-BDBA-3474570FD8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50603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632886"/>
            <a:ext cx="10515600" cy="229764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3164417"/>
            <a:ext cx="10515600" cy="754231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1017676"/>
            <a:ext cx="2743200" cy="6328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ED46390-1553-4345-8BF4-449A06A77731}" type="datetimeFigureOut">
              <a:rPr lang="en-US" smtClean="0"/>
              <a:t>1/3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1017676"/>
            <a:ext cx="4114800" cy="6328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1017676"/>
            <a:ext cx="2743200" cy="6328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D558637-D2F5-4B93-BDBA-3474570FD8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60622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screenshot of a computer screen&#10;&#10;Description automatically generated">
            <a:extLst>
              <a:ext uri="{FF2B5EF4-FFF2-40B4-BE49-F238E27FC236}">
                <a16:creationId xmlns:a16="http://schemas.microsoft.com/office/drawing/2014/main" id="{83C5E329-1F01-DFF3-5A35-D21EAF3152E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631" t="5274" r="16927" b="4818"/>
          <a:stretch/>
        </p:blipFill>
        <p:spPr>
          <a:xfrm>
            <a:off x="397858" y="908838"/>
            <a:ext cx="3229761" cy="2466366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9" name="Picture 8" descr="A map of different colored dots&#10;&#10;Description automatically generated">
            <a:extLst>
              <a:ext uri="{FF2B5EF4-FFF2-40B4-BE49-F238E27FC236}">
                <a16:creationId xmlns:a16="http://schemas.microsoft.com/office/drawing/2014/main" id="{471057F5-A5FE-C89F-FD41-D4D542C7474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40" t="5274" r="16312" b="4818"/>
          <a:stretch/>
        </p:blipFill>
        <p:spPr>
          <a:xfrm>
            <a:off x="7002478" y="908840"/>
            <a:ext cx="3130639" cy="2466366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11" name="Picture 10" descr="A colorful dots on a white background&#10;&#10;Description automatically generated">
            <a:extLst>
              <a:ext uri="{FF2B5EF4-FFF2-40B4-BE49-F238E27FC236}">
                <a16:creationId xmlns:a16="http://schemas.microsoft.com/office/drawing/2014/main" id="{46B25414-4F38-7A3A-7B56-86578AE0DE6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556" t="5273" r="17291" b="4818"/>
          <a:stretch/>
        </p:blipFill>
        <p:spPr>
          <a:xfrm>
            <a:off x="309153" y="3727537"/>
            <a:ext cx="3407170" cy="2466365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13" name="Picture 12" descr="A screenshot of a computer screen&#10;&#10;Description automatically generated">
            <a:extLst>
              <a:ext uri="{FF2B5EF4-FFF2-40B4-BE49-F238E27FC236}">
                <a16:creationId xmlns:a16="http://schemas.microsoft.com/office/drawing/2014/main" id="{FE7AC0CA-1609-C580-BB48-B6DD23B5851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85" t="5273" r="15754" b="4818"/>
          <a:stretch/>
        </p:blipFill>
        <p:spPr>
          <a:xfrm>
            <a:off x="3736231" y="3727537"/>
            <a:ext cx="3130639" cy="2466365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14" name="Picture 13" descr="A colorful dots on a white background&#10;&#10;Description automatically generated">
            <a:extLst>
              <a:ext uri="{FF2B5EF4-FFF2-40B4-BE49-F238E27FC236}">
                <a16:creationId xmlns:a16="http://schemas.microsoft.com/office/drawing/2014/main" id="{E5A18C32-6934-3853-62EC-FF385D9D1EBA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91" t="5274" r="17696" b="4819"/>
          <a:stretch/>
        </p:blipFill>
        <p:spPr>
          <a:xfrm>
            <a:off x="3686670" y="908839"/>
            <a:ext cx="3229761" cy="2466366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A177EEAB-C861-A638-A21D-22B08B219D7C}"/>
              </a:ext>
            </a:extLst>
          </p:cNvPr>
          <p:cNvSpPr txBox="1"/>
          <p:nvPr/>
        </p:nvSpPr>
        <p:spPr>
          <a:xfrm>
            <a:off x="1501679" y="635379"/>
            <a:ext cx="1072451" cy="276999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algn="ctr"/>
            <a:r>
              <a:rPr lang="en-US" sz="1200" b="1" dirty="0"/>
              <a:t>CONCH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7675BB9-5D55-72F9-C809-207E36C7D363}"/>
              </a:ext>
            </a:extLst>
          </p:cNvPr>
          <p:cNvSpPr txBox="1"/>
          <p:nvPr/>
        </p:nvSpPr>
        <p:spPr>
          <a:xfrm>
            <a:off x="4764133" y="635379"/>
            <a:ext cx="1072451" cy="276999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algn="ctr"/>
            <a:r>
              <a:rPr lang="en-US" sz="1200" b="1" dirty="0" err="1"/>
              <a:t>Hibou</a:t>
            </a:r>
            <a:r>
              <a:rPr lang="en-US" sz="1200" b="1" dirty="0"/>
              <a:t>-L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9D3580C-F1DF-8FDF-A8AE-1DA8A4C7D3F7}"/>
              </a:ext>
            </a:extLst>
          </p:cNvPr>
          <p:cNvSpPr txBox="1"/>
          <p:nvPr/>
        </p:nvSpPr>
        <p:spPr>
          <a:xfrm>
            <a:off x="8093281" y="635379"/>
            <a:ext cx="1072451" cy="276999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algn="ctr"/>
            <a:r>
              <a:rPr lang="en-US" sz="1200" b="1" dirty="0" err="1"/>
              <a:t>Phikon</a:t>
            </a:r>
            <a:endParaRPr lang="en-US" sz="1200" b="1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3F8028E-1177-6EF6-3578-4BB7D7595200}"/>
              </a:ext>
            </a:extLst>
          </p:cNvPr>
          <p:cNvSpPr txBox="1"/>
          <p:nvPr/>
        </p:nvSpPr>
        <p:spPr>
          <a:xfrm>
            <a:off x="1230799" y="3475703"/>
            <a:ext cx="1563879" cy="276999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algn="ctr"/>
            <a:r>
              <a:rPr lang="en-US" sz="1200" b="1" dirty="0"/>
              <a:t>Prov-</a:t>
            </a:r>
            <a:r>
              <a:rPr lang="en-US" sz="1200" b="1" dirty="0" err="1"/>
              <a:t>gigapath</a:t>
            </a:r>
            <a:endParaRPr lang="en-US" sz="1200" b="1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BF113A0-CEBE-3D40-0592-E166894BFDB7}"/>
              </a:ext>
            </a:extLst>
          </p:cNvPr>
          <p:cNvSpPr txBox="1"/>
          <p:nvPr/>
        </p:nvSpPr>
        <p:spPr>
          <a:xfrm>
            <a:off x="4519611" y="3451083"/>
            <a:ext cx="1563879" cy="276999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algn="ctr"/>
            <a:r>
              <a:rPr lang="en-US" sz="1200" b="1" dirty="0"/>
              <a:t>UNI</a:t>
            </a:r>
          </a:p>
        </p:txBody>
      </p:sp>
      <p:pic>
        <p:nvPicPr>
          <p:cNvPr id="23" name="Picture 22" descr="A screenshot of a computer game&#10;&#10;Description automatically generated">
            <a:extLst>
              <a:ext uri="{FF2B5EF4-FFF2-40B4-BE49-F238E27FC236}">
                <a16:creationId xmlns:a16="http://schemas.microsoft.com/office/drawing/2014/main" id="{5A43BD8E-0296-280B-C4E0-4E7ED051FFD1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91" t="5029" r="17734" b="5062"/>
          <a:stretch/>
        </p:blipFill>
        <p:spPr>
          <a:xfrm>
            <a:off x="7229638" y="3749139"/>
            <a:ext cx="2676319" cy="2423160"/>
          </a:xfrm>
          <a:prstGeom prst="rect">
            <a:avLst/>
          </a:prstGeom>
        </p:spPr>
      </p:pic>
      <p:pic>
        <p:nvPicPr>
          <p:cNvPr id="25" name="Picture 24" descr="A screenshot of a computer screen&#10;&#10;Description automatically generated">
            <a:extLst>
              <a:ext uri="{FF2B5EF4-FFF2-40B4-BE49-F238E27FC236}">
                <a16:creationId xmlns:a16="http://schemas.microsoft.com/office/drawing/2014/main" id="{AC305CDB-0568-CF2F-5A65-AB06E26D54F3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274" r="17370"/>
          <a:stretch/>
        </p:blipFill>
        <p:spPr>
          <a:xfrm>
            <a:off x="444337" y="6561639"/>
            <a:ext cx="3136803" cy="2598540"/>
          </a:xfrm>
          <a:prstGeom prst="rect">
            <a:avLst/>
          </a:prstGeom>
        </p:spPr>
      </p:pic>
      <p:pic>
        <p:nvPicPr>
          <p:cNvPr id="27" name="Picture 26" descr="A screenshot of a computer screen&#10;&#10;Description automatically generated">
            <a:extLst>
              <a:ext uri="{FF2B5EF4-FFF2-40B4-BE49-F238E27FC236}">
                <a16:creationId xmlns:a16="http://schemas.microsoft.com/office/drawing/2014/main" id="{DAC157A2-3476-8898-DBF0-949D18729A2C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24" t="4150" r="17586"/>
          <a:stretch/>
        </p:blipFill>
        <p:spPr>
          <a:xfrm>
            <a:off x="3991839" y="6546232"/>
            <a:ext cx="2619423" cy="2629355"/>
          </a:xfrm>
          <a:prstGeom prst="rect">
            <a:avLst/>
          </a:prstGeom>
        </p:spPr>
      </p:pic>
      <p:pic>
        <p:nvPicPr>
          <p:cNvPr id="29" name="Picture 28" descr="A screen shot of a computer screen&#10;&#10;Description automatically generated">
            <a:extLst>
              <a:ext uri="{FF2B5EF4-FFF2-40B4-BE49-F238E27FC236}">
                <a16:creationId xmlns:a16="http://schemas.microsoft.com/office/drawing/2014/main" id="{B26A75BB-84C9-3AC1-9BC0-1BA6560B2A7D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12" t="4150" r="17824"/>
          <a:stretch/>
        </p:blipFill>
        <p:spPr>
          <a:xfrm>
            <a:off x="7258085" y="6546232"/>
            <a:ext cx="2619424" cy="2629355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9AF9A77E-E11D-F16D-4A40-E2E570F53E73}"/>
              </a:ext>
            </a:extLst>
          </p:cNvPr>
          <p:cNvSpPr txBox="1"/>
          <p:nvPr/>
        </p:nvSpPr>
        <p:spPr>
          <a:xfrm>
            <a:off x="7785858" y="3450537"/>
            <a:ext cx="1563879" cy="276999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algn="ctr"/>
            <a:r>
              <a:rPr lang="en-US" sz="1200" b="1" dirty="0" err="1"/>
              <a:t>ConvNext</a:t>
            </a:r>
            <a:endParaRPr lang="en-US" sz="1200" b="1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687A63CA-26D3-3EF8-F043-15A682F3EB73}"/>
              </a:ext>
            </a:extLst>
          </p:cNvPr>
          <p:cNvSpPr txBox="1"/>
          <p:nvPr/>
        </p:nvSpPr>
        <p:spPr>
          <a:xfrm>
            <a:off x="1230799" y="6307236"/>
            <a:ext cx="1563879" cy="276999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algn="ctr"/>
            <a:r>
              <a:rPr lang="en-US" sz="1200" b="1" dirty="0"/>
              <a:t>DINOv2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D5FA35A-8AB4-428A-D823-4425E2D0B96B}"/>
              </a:ext>
            </a:extLst>
          </p:cNvPr>
          <p:cNvSpPr txBox="1"/>
          <p:nvPr/>
        </p:nvSpPr>
        <p:spPr>
          <a:xfrm>
            <a:off x="4519611" y="6282616"/>
            <a:ext cx="1563879" cy="276999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algn="ctr"/>
            <a:r>
              <a:rPr lang="en-US" sz="1200" b="1" dirty="0" err="1"/>
              <a:t>EfficientNet</a:t>
            </a:r>
            <a:endParaRPr lang="en-US" sz="1200" b="1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AB76314D-8321-5906-45EB-8AE41A5B2C77}"/>
              </a:ext>
            </a:extLst>
          </p:cNvPr>
          <p:cNvSpPr txBox="1"/>
          <p:nvPr/>
        </p:nvSpPr>
        <p:spPr>
          <a:xfrm>
            <a:off x="7785858" y="6282070"/>
            <a:ext cx="1563879" cy="276999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algn="ctr"/>
            <a:r>
              <a:rPr lang="en-US" sz="1200" b="1" dirty="0" err="1"/>
              <a:t>ResNet</a:t>
            </a:r>
            <a:endParaRPr lang="en-US" sz="1200" b="1" dirty="0"/>
          </a:p>
        </p:txBody>
      </p:sp>
      <p:grpSp>
        <p:nvGrpSpPr>
          <p:cNvPr id="42" name="Group 41">
            <a:extLst>
              <a:ext uri="{FF2B5EF4-FFF2-40B4-BE49-F238E27FC236}">
                <a16:creationId xmlns:a16="http://schemas.microsoft.com/office/drawing/2014/main" id="{23C312F5-E6F0-FDFF-18EE-6109E6FAB48A}"/>
              </a:ext>
            </a:extLst>
          </p:cNvPr>
          <p:cNvGrpSpPr/>
          <p:nvPr/>
        </p:nvGrpSpPr>
        <p:grpSpPr>
          <a:xfrm>
            <a:off x="3627619" y="9175587"/>
            <a:ext cx="3689259" cy="691316"/>
            <a:chOff x="3627619" y="9175587"/>
            <a:chExt cx="3689259" cy="691316"/>
          </a:xfrm>
        </p:grpSpPr>
        <p:grpSp>
          <p:nvGrpSpPr>
            <p:cNvPr id="40" name="Group 39">
              <a:extLst>
                <a:ext uri="{FF2B5EF4-FFF2-40B4-BE49-F238E27FC236}">
                  <a16:creationId xmlns:a16="http://schemas.microsoft.com/office/drawing/2014/main" id="{992ED330-4312-6EE9-BEE9-49337D9DFB72}"/>
                </a:ext>
              </a:extLst>
            </p:cNvPr>
            <p:cNvGrpSpPr/>
            <p:nvPr/>
          </p:nvGrpSpPr>
          <p:grpSpPr>
            <a:xfrm>
              <a:off x="3635437" y="9175587"/>
              <a:ext cx="1279209" cy="369332"/>
              <a:chOff x="719305" y="9175587"/>
              <a:chExt cx="1279209" cy="369332"/>
            </a:xfrm>
          </p:grpSpPr>
          <p:sp>
            <p:nvSpPr>
              <p:cNvPr id="4" name="Rectangle 3">
                <a:extLst>
                  <a:ext uri="{FF2B5EF4-FFF2-40B4-BE49-F238E27FC236}">
                    <a16:creationId xmlns:a16="http://schemas.microsoft.com/office/drawing/2014/main" id="{B0B253E8-AA81-7784-4CF4-BD1BCFB24810}"/>
                  </a:ext>
                </a:extLst>
              </p:cNvPr>
              <p:cNvSpPr/>
              <p:nvPr/>
            </p:nvSpPr>
            <p:spPr>
              <a:xfrm>
                <a:off x="719305" y="9255381"/>
                <a:ext cx="209745" cy="209745"/>
              </a:xfrm>
              <a:prstGeom prst="rect">
                <a:avLst/>
              </a:prstGeom>
              <a:solidFill>
                <a:srgbClr val="0000FF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B09B9FCC-A94F-3F87-8E20-AFBC0DF3C14A}"/>
                  </a:ext>
                </a:extLst>
              </p:cNvPr>
              <p:cNvSpPr txBox="1"/>
              <p:nvPr/>
            </p:nvSpPr>
            <p:spPr>
              <a:xfrm>
                <a:off x="934080" y="9175587"/>
                <a:ext cx="106443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Amnion</a:t>
                </a:r>
              </a:p>
            </p:txBody>
          </p:sp>
        </p:grpSp>
        <p:grpSp>
          <p:nvGrpSpPr>
            <p:cNvPr id="41" name="Group 40">
              <a:extLst>
                <a:ext uri="{FF2B5EF4-FFF2-40B4-BE49-F238E27FC236}">
                  <a16:creationId xmlns:a16="http://schemas.microsoft.com/office/drawing/2014/main" id="{1A59A6F7-27CB-8604-E739-4B84FA98A6B3}"/>
                </a:ext>
              </a:extLst>
            </p:cNvPr>
            <p:cNvGrpSpPr/>
            <p:nvPr/>
          </p:nvGrpSpPr>
          <p:grpSpPr>
            <a:xfrm>
              <a:off x="3627619" y="9497571"/>
              <a:ext cx="1272793" cy="369332"/>
              <a:chOff x="719305" y="9497571"/>
              <a:chExt cx="1272793" cy="369332"/>
            </a:xfrm>
          </p:grpSpPr>
          <p:sp>
            <p:nvSpPr>
              <p:cNvPr id="7" name="Rectangle 6">
                <a:extLst>
                  <a:ext uri="{FF2B5EF4-FFF2-40B4-BE49-F238E27FC236}">
                    <a16:creationId xmlns:a16="http://schemas.microsoft.com/office/drawing/2014/main" id="{B000EBE4-CD29-855E-EA96-660F9A0EDBA6}"/>
                  </a:ext>
                </a:extLst>
              </p:cNvPr>
              <p:cNvSpPr/>
              <p:nvPr/>
            </p:nvSpPr>
            <p:spPr>
              <a:xfrm>
                <a:off x="719305" y="9577365"/>
                <a:ext cx="209745" cy="209745"/>
              </a:xfrm>
              <a:prstGeom prst="rect">
                <a:avLst/>
              </a:prstGeom>
              <a:solidFill>
                <a:srgbClr val="FFA5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C0737803-860C-7FCA-FFD5-94D8C9728C79}"/>
                  </a:ext>
                </a:extLst>
              </p:cNvPr>
              <p:cNvSpPr txBox="1"/>
              <p:nvPr/>
            </p:nvSpPr>
            <p:spPr>
              <a:xfrm>
                <a:off x="934079" y="9497571"/>
                <a:ext cx="105801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Decidua</a:t>
                </a:r>
              </a:p>
            </p:txBody>
          </p:sp>
        </p:grpSp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252A73A2-FF27-5B3B-8DB4-DBF1FCE9D9B7}"/>
                </a:ext>
              </a:extLst>
            </p:cNvPr>
            <p:cNvGrpSpPr/>
            <p:nvPr/>
          </p:nvGrpSpPr>
          <p:grpSpPr>
            <a:xfrm>
              <a:off x="5013568" y="9175587"/>
              <a:ext cx="975566" cy="369332"/>
              <a:chOff x="3788567" y="9112464"/>
              <a:chExt cx="975566" cy="369332"/>
            </a:xfrm>
          </p:grpSpPr>
          <p:sp>
            <p:nvSpPr>
              <p:cNvPr id="10" name="Rectangle 9">
                <a:extLst>
                  <a:ext uri="{FF2B5EF4-FFF2-40B4-BE49-F238E27FC236}">
                    <a16:creationId xmlns:a16="http://schemas.microsoft.com/office/drawing/2014/main" id="{AF788E49-DDA2-C715-BD4F-449B1C7FD50B}"/>
                  </a:ext>
                </a:extLst>
              </p:cNvPr>
              <p:cNvSpPr/>
              <p:nvPr/>
            </p:nvSpPr>
            <p:spPr>
              <a:xfrm>
                <a:off x="3788567" y="9192258"/>
                <a:ext cx="209745" cy="209745"/>
              </a:xfrm>
              <a:prstGeom prst="rect">
                <a:avLst/>
              </a:prstGeom>
              <a:solidFill>
                <a:srgbClr val="008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858EE895-3493-A0D7-5D2A-36A3AF002D58}"/>
                  </a:ext>
                </a:extLst>
              </p:cNvPr>
              <p:cNvSpPr txBox="1"/>
              <p:nvPr/>
            </p:nvSpPr>
            <p:spPr>
              <a:xfrm>
                <a:off x="4006072" y="9112464"/>
                <a:ext cx="75806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Fibrin</a:t>
                </a:r>
              </a:p>
            </p:txBody>
          </p:sp>
        </p:grpSp>
        <p:grpSp>
          <p:nvGrpSpPr>
            <p:cNvPr id="38" name="Group 37">
              <a:extLst>
                <a:ext uri="{FF2B5EF4-FFF2-40B4-BE49-F238E27FC236}">
                  <a16:creationId xmlns:a16="http://schemas.microsoft.com/office/drawing/2014/main" id="{A899B279-E5A0-F324-2123-410E0CB9CF62}"/>
                </a:ext>
              </a:extLst>
            </p:cNvPr>
            <p:cNvGrpSpPr/>
            <p:nvPr/>
          </p:nvGrpSpPr>
          <p:grpSpPr>
            <a:xfrm>
              <a:off x="6227628" y="9175587"/>
              <a:ext cx="1089250" cy="369332"/>
              <a:chOff x="7274364" y="9175587"/>
              <a:chExt cx="1089250" cy="369332"/>
            </a:xfrm>
          </p:grpSpPr>
          <p:sp>
            <p:nvSpPr>
              <p:cNvPr id="20" name="Rectangle 19">
                <a:extLst>
                  <a:ext uri="{FF2B5EF4-FFF2-40B4-BE49-F238E27FC236}">
                    <a16:creationId xmlns:a16="http://schemas.microsoft.com/office/drawing/2014/main" id="{FAC5613B-9187-B2F7-E224-EF382B47A36E}"/>
                  </a:ext>
                </a:extLst>
              </p:cNvPr>
              <p:cNvSpPr/>
              <p:nvPr/>
            </p:nvSpPr>
            <p:spPr>
              <a:xfrm>
                <a:off x="7274364" y="9255381"/>
                <a:ext cx="209745" cy="209745"/>
              </a:xfrm>
              <a:prstGeom prst="rect">
                <a:avLst/>
              </a:prstGeom>
              <a:solidFill>
                <a:srgbClr val="80008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DC990B61-FB58-A35E-97FB-D00A803E6814}"/>
                  </a:ext>
                </a:extLst>
              </p:cNvPr>
              <p:cNvSpPr txBox="1"/>
              <p:nvPr/>
            </p:nvSpPr>
            <p:spPr>
              <a:xfrm>
                <a:off x="7484110" y="9175587"/>
                <a:ext cx="87950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Stem</a:t>
                </a:r>
              </a:p>
            </p:txBody>
          </p:sp>
        </p:grpSp>
        <p:grpSp>
          <p:nvGrpSpPr>
            <p:cNvPr id="37" name="Group 36">
              <a:extLst>
                <a:ext uri="{FF2B5EF4-FFF2-40B4-BE49-F238E27FC236}">
                  <a16:creationId xmlns:a16="http://schemas.microsoft.com/office/drawing/2014/main" id="{C3874925-C012-77C2-8DED-E953D34E4DF5}"/>
                </a:ext>
              </a:extLst>
            </p:cNvPr>
            <p:cNvGrpSpPr/>
            <p:nvPr/>
          </p:nvGrpSpPr>
          <p:grpSpPr>
            <a:xfrm>
              <a:off x="5021328" y="9497571"/>
              <a:ext cx="1051814" cy="369332"/>
              <a:chOff x="4116913" y="10365716"/>
              <a:chExt cx="1051814" cy="369332"/>
            </a:xfrm>
          </p:grpSpPr>
          <p:sp>
            <p:nvSpPr>
              <p:cNvPr id="22" name="Rectangle 21">
                <a:extLst>
                  <a:ext uri="{FF2B5EF4-FFF2-40B4-BE49-F238E27FC236}">
                    <a16:creationId xmlns:a16="http://schemas.microsoft.com/office/drawing/2014/main" id="{95B60C69-BE69-81E8-48C3-F6C1B413ADB1}"/>
                  </a:ext>
                </a:extLst>
              </p:cNvPr>
              <p:cNvSpPr/>
              <p:nvPr/>
            </p:nvSpPr>
            <p:spPr>
              <a:xfrm>
                <a:off x="4116913" y="10445509"/>
                <a:ext cx="209745" cy="209745"/>
              </a:xfrm>
              <a:prstGeom prst="rect">
                <a:avLst/>
              </a:prstGeom>
              <a:solidFill>
                <a:srgbClr val="FF0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3F4D3524-CD4A-C782-681D-CACCEC4E820D}"/>
                  </a:ext>
                </a:extLst>
              </p:cNvPr>
              <p:cNvSpPr txBox="1"/>
              <p:nvPr/>
            </p:nvSpPr>
            <p:spPr>
              <a:xfrm>
                <a:off x="4326659" y="10365716"/>
                <a:ext cx="84206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Glass</a:t>
                </a:r>
              </a:p>
            </p:txBody>
          </p:sp>
        </p:grpSp>
        <p:grpSp>
          <p:nvGrpSpPr>
            <p:cNvPr id="39" name="Group 38">
              <a:extLst>
                <a:ext uri="{FF2B5EF4-FFF2-40B4-BE49-F238E27FC236}">
                  <a16:creationId xmlns:a16="http://schemas.microsoft.com/office/drawing/2014/main" id="{E160E0A0-03B7-6D8C-29C2-1AC4B1264A43}"/>
                </a:ext>
              </a:extLst>
            </p:cNvPr>
            <p:cNvGrpSpPr/>
            <p:nvPr/>
          </p:nvGrpSpPr>
          <p:grpSpPr>
            <a:xfrm>
              <a:off x="6227627" y="9497571"/>
              <a:ext cx="1089250" cy="369332"/>
              <a:chOff x="7358371" y="9523048"/>
              <a:chExt cx="1089250" cy="369332"/>
            </a:xfrm>
          </p:grpSpPr>
          <p:sp>
            <p:nvSpPr>
              <p:cNvPr id="26" name="Rectangle 25">
                <a:extLst>
                  <a:ext uri="{FF2B5EF4-FFF2-40B4-BE49-F238E27FC236}">
                    <a16:creationId xmlns:a16="http://schemas.microsoft.com/office/drawing/2014/main" id="{14CB296C-677C-CB08-2E85-C7DA551FACBB}"/>
                  </a:ext>
                </a:extLst>
              </p:cNvPr>
              <p:cNvSpPr/>
              <p:nvPr/>
            </p:nvSpPr>
            <p:spPr>
              <a:xfrm>
                <a:off x="7358371" y="9602842"/>
                <a:ext cx="209745" cy="209745"/>
              </a:xfrm>
              <a:prstGeom prst="rect">
                <a:avLst/>
              </a:prstGeom>
              <a:solidFill>
                <a:srgbClr val="A52A2A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9A67CDF9-EC78-64BB-921B-39D3F2D1B3CE}"/>
                  </a:ext>
                </a:extLst>
              </p:cNvPr>
              <p:cNvSpPr txBox="1"/>
              <p:nvPr/>
            </p:nvSpPr>
            <p:spPr>
              <a:xfrm>
                <a:off x="7568116" y="9523048"/>
                <a:ext cx="87950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Villi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3295879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</TotalTime>
  <Words>16</Words>
  <Application>Microsoft Office PowerPoint</Application>
  <PresentationFormat>Custom</PresentationFormat>
  <Paragraphs>1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effery Adam Goldstein</dc:creator>
  <cp:lastModifiedBy>Jeffery Adam Goldstein</cp:lastModifiedBy>
  <cp:revision>2</cp:revision>
  <dcterms:created xsi:type="dcterms:W3CDTF">2025-01-30T23:45:06Z</dcterms:created>
  <dcterms:modified xsi:type="dcterms:W3CDTF">2025-01-31T00:09:21Z</dcterms:modified>
</cp:coreProperties>
</file>